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8" r:id="rId2"/>
    <p:sldId id="261" r:id="rId3"/>
    <p:sldId id="262" r:id="rId4"/>
    <p:sldId id="263" r:id="rId5"/>
    <p:sldId id="264" r:id="rId6"/>
    <p:sldId id="25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>
        <p:scale>
          <a:sx n="60" d="100"/>
          <a:sy n="60" d="100"/>
        </p:scale>
        <p:origin x="11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73FC5B-BC8B-49EC-99CC-BCCAAF95CD10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95BCBB-1851-4E2B-9DF5-8AE59E0B2D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7413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5BCBB-1851-4E2B-9DF5-8AE59E0B2D6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01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5BCBB-1851-4E2B-9DF5-8AE59E0B2D6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08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6D21DBA-F4CA-659F-D1CC-C88159DB24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DD27220-19F1-E036-F3D1-3D131FECCE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0784052-2DBB-45B6-BE12-359E9D15E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A857767-7CAB-FD94-05E2-BAED3D42E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F4528EF-121D-2412-AEA1-E5D3E1D51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12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65BDAB-4526-C425-7CDA-FCE41B649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632CB73-161B-8161-12A9-B66D9DE648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A9BAB1C-50A2-219B-0A97-8BD2BF6FC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3EB48FE-711B-3B3C-B56C-418EB0583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74478B7-A73B-A3C1-67DE-678278149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999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427DE70-4DB5-E88D-B225-E727EAE2E4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84713CD-3983-D8DF-4C84-E724E0952B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9A4BD4F-FA87-E06C-F2DA-1EADF1FA9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DA2A840-3A6D-5C48-F7A0-BD81FEFBF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409D689-274D-5F6E-B11C-77430DC20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836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B7A960-9B21-769D-1783-F492A67E5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2A4FD56-3B3C-ACCC-99B1-AD0AE250D5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BEC0B4D-1CC9-EBD6-F75B-688610CC2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3BA2973-D85F-6B3A-385C-BAE2A722C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AB21BE1-8570-1AEF-0A52-249E67800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939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52F9AD-EF72-4E35-14DF-F6C97890D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9A0B0CE-415E-5128-09F7-327A19C54C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1A29541-9520-A57D-B21C-050CE8F36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1D56321-BD3A-5566-8167-5A02B6FD2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56C44A2-6804-CF51-3A39-2D7ADDA58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230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A6992A-5151-5820-B197-1E8689BBB4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EF67C9A-BA77-6960-CF0C-F8E53A85A4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BE37F49-AF4D-03B9-D617-84F4E79331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D620AE8-E129-6847-53B7-0D76FC320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9613E3A-5928-F360-AF76-309132A96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CE8230E-757D-C8F7-EDEE-B3502C272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308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761122-9BE7-5A4F-35E9-38316789E3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F44D6E6-69B5-C20D-C7A1-07457DC40C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9952188-7C25-5259-E8EA-E2F753795F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816073E-AD13-328B-9E45-33ECEFABD3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D044F13-B106-C7FF-79C5-9DD7773B09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C359DEF-F82A-4773-7A96-D06E38FB3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0D4B2B9-B649-6EF2-5337-F343659ED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BDFF429-4657-3739-7B44-8BB68539B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015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299C4DC-4F79-771A-1F8D-2E0DD42D8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749953A-4267-B2B3-A250-C47361C0C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79D4FA6-8ACA-CAD2-F864-92E126CF0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CBE2C44-BE62-2AF3-3EA7-2E26E653E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139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C4250B2E-8ED3-1964-5218-22CAA0B94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3C608EC-AF5A-2B63-7BBA-0FC7F8478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0059E39-006B-3B02-7F6C-8228B4AC7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519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9B5D3E7-22BB-D887-8998-59DA87C53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A11E4E3-F823-B476-D441-4FBB213260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C7FC855-2502-BD44-AD10-AB1DA51CCC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2773961-67A0-A305-F4A6-6510BD312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68AC588-8550-4A40-5146-D0234B670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B658ECE-4DAB-B073-B364-767A37B8D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74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7306EF-531C-12EA-71B4-96859D9E74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0F82FD3-5858-6BC7-8A66-06E843C4FD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127B87A-A8B9-B344-4C9C-134BEF22E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3E26836-8F55-6EF8-33BF-E6144EB15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924F7FC-D1BE-5689-79F5-EF9B40458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AF62CB5-7BEE-61BF-BC2F-08FDFF809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47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F45257F-9496-BD8E-FF7D-E3CDBCC23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33BE983-B4AB-A400-D936-B7F20DD63D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DF8C88E-E90A-7A45-D23F-B1E731338C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9C6F21-8018-4A93-8472-4B7A7D253B24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E635A33-0D82-E1F9-CA1E-933BFA3521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582D0C0-1F70-408D-31A4-58955022FB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23059D-ACC1-4859-9B41-17E6BDEE090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908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tif"/><Relationship Id="rId4" Type="http://schemas.openxmlformats.org/officeDocument/2006/relationships/image" Target="../media/image4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A09A749D-BF59-2154-2F18-9C94EDC387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29918" r="46885" b="34217"/>
          <a:stretch/>
        </p:blipFill>
        <p:spPr>
          <a:xfrm>
            <a:off x="397534" y="773580"/>
            <a:ext cx="4199444" cy="2727158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C10A9AE-FA0F-6B93-39FF-8BF1914F4CA9}"/>
              </a:ext>
            </a:extLst>
          </p:cNvPr>
          <p:cNvSpPr txBox="1"/>
          <p:nvPr/>
        </p:nvSpPr>
        <p:spPr>
          <a:xfrm>
            <a:off x="4708128" y="1615477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ISD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B97136B3-4AE2-3DE6-E08A-3CDBB2341077}"/>
              </a:ext>
            </a:extLst>
          </p:cNvPr>
          <p:cNvGrpSpPr/>
          <p:nvPr/>
        </p:nvGrpSpPr>
        <p:grpSpPr>
          <a:xfrm>
            <a:off x="1019565" y="1074821"/>
            <a:ext cx="646680" cy="601049"/>
            <a:chOff x="970459" y="1661548"/>
            <a:chExt cx="646680" cy="601049"/>
          </a:xfrm>
        </p:grpSpPr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8B28B92B-FBED-9AC8-C056-0E0E11029ED9}"/>
                </a:ext>
              </a:extLst>
            </p:cNvPr>
            <p:cNvSpPr txBox="1"/>
            <p:nvPr/>
          </p:nvSpPr>
          <p:spPr>
            <a:xfrm rot="16200000">
              <a:off x="952185" y="1868010"/>
              <a:ext cx="4058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>
                  <a:latin typeface="Arial" panose="020B0604020202020204" pitchFamily="34" charset="0"/>
                  <a:cs typeface="Arial" panose="020B0604020202020204" pitchFamily="34" charset="0"/>
                </a:rPr>
                <a:t>ρ</a:t>
              </a:r>
              <a:r>
                <a:rPr 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076F3289-DE2B-11B7-0BC8-A30DB8090413}"/>
                </a:ext>
              </a:extLst>
            </p:cNvPr>
            <p:cNvSpPr txBox="1"/>
            <p:nvPr/>
          </p:nvSpPr>
          <p:spPr>
            <a:xfrm rot="16200000">
              <a:off x="1131948" y="1777407"/>
              <a:ext cx="601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>
                  <a:latin typeface="Arial" panose="020B0604020202020204" pitchFamily="34" charset="0"/>
                  <a:cs typeface="Arial" panose="020B0604020202020204" pitchFamily="34" charset="0"/>
                </a:rPr>
                <a:t>ρ</a:t>
              </a:r>
              <a:r>
                <a:rPr 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pic>
        <p:nvPicPr>
          <p:cNvPr id="18" name="Imagen 1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F5B3C04-5E8E-69C1-35D8-3C2B28EF4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1" t="39548" r="38550" b="26628"/>
          <a:stretch/>
        </p:blipFill>
        <p:spPr>
          <a:xfrm>
            <a:off x="373132" y="3811936"/>
            <a:ext cx="4248248" cy="2623920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D1534B06-B5FE-EAB6-5965-B9A4B570DE0D}"/>
              </a:ext>
            </a:extLst>
          </p:cNvPr>
          <p:cNvSpPr txBox="1"/>
          <p:nvPr/>
        </p:nvSpPr>
        <p:spPr>
          <a:xfrm>
            <a:off x="4704189" y="5720805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0A1F41C-2700-357D-9384-3D3BD22E2411}"/>
              </a:ext>
            </a:extLst>
          </p:cNvPr>
          <p:cNvSpPr txBox="1"/>
          <p:nvPr/>
        </p:nvSpPr>
        <p:spPr>
          <a:xfrm>
            <a:off x="4704189" y="4008149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22" name="Imagen 21" descr="Un conjunto de letras blancas en un fondo blanco&#10;&#10;Descripción generada automáticamente con confianza baja">
            <a:extLst>
              <a:ext uri="{FF2B5EF4-FFF2-40B4-BE49-F238E27FC236}">
                <a16:creationId xmlns:a16="http://schemas.microsoft.com/office/drawing/2014/main" id="{17F39753-314F-2685-FCBD-A15BCEF87F4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20" t="32685" r="34913" b="25974"/>
          <a:stretch/>
        </p:blipFill>
        <p:spPr>
          <a:xfrm>
            <a:off x="6070732" y="708121"/>
            <a:ext cx="4134074" cy="2683882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744D2C7A-1B73-16C6-8880-9299D0E78B6A}"/>
              </a:ext>
            </a:extLst>
          </p:cNvPr>
          <p:cNvSpPr txBox="1"/>
          <p:nvPr/>
        </p:nvSpPr>
        <p:spPr>
          <a:xfrm>
            <a:off x="10204806" y="183382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TDSS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4D70574B-5D10-1C14-43F9-77A2A9B57655}"/>
              </a:ext>
            </a:extLst>
          </p:cNvPr>
          <p:cNvSpPr txBox="1"/>
          <p:nvPr/>
        </p:nvSpPr>
        <p:spPr>
          <a:xfrm>
            <a:off x="4782469" y="133654"/>
            <a:ext cx="11801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1C  </a:t>
            </a:r>
          </a:p>
        </p:txBody>
      </p:sp>
    </p:spTree>
    <p:extLst>
      <p:ext uri="{BB962C8B-B14F-4D97-AF65-F5344CB8AC3E}">
        <p14:creationId xmlns:p14="http://schemas.microsoft.com/office/powerpoint/2010/main" val="31276472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A09A749D-BF59-2154-2F18-9C94EDC387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29918" r="46885" b="34217"/>
          <a:stretch/>
        </p:blipFill>
        <p:spPr>
          <a:xfrm>
            <a:off x="397534" y="534841"/>
            <a:ext cx="3201674" cy="1985661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C10A9AE-FA0F-6B93-39FF-8BF1914F4CA9}"/>
              </a:ext>
            </a:extLst>
          </p:cNvPr>
          <p:cNvSpPr txBox="1"/>
          <p:nvPr/>
        </p:nvSpPr>
        <p:spPr>
          <a:xfrm>
            <a:off x="3769206" y="103554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ISD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B97136B3-4AE2-3DE6-E08A-3CDBB2341077}"/>
              </a:ext>
            </a:extLst>
          </p:cNvPr>
          <p:cNvGrpSpPr/>
          <p:nvPr/>
        </p:nvGrpSpPr>
        <p:grpSpPr>
          <a:xfrm>
            <a:off x="1340289" y="431877"/>
            <a:ext cx="671219" cy="847035"/>
            <a:chOff x="1515284" y="1115478"/>
            <a:chExt cx="880398" cy="1163339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1BB3EF02-CDBC-088F-4F78-9FCB7AE9E14C}"/>
                </a:ext>
              </a:extLst>
            </p:cNvPr>
            <p:cNvSpPr txBox="1"/>
            <p:nvPr/>
          </p:nvSpPr>
          <p:spPr>
            <a:xfrm rot="16200000">
              <a:off x="1175830" y="1454932"/>
              <a:ext cx="1163339" cy="4844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CA185479-3ED5-56CE-F1E0-D95C8800715F}"/>
                </a:ext>
              </a:extLst>
            </p:cNvPr>
            <p:cNvSpPr txBox="1"/>
            <p:nvPr/>
          </p:nvSpPr>
          <p:spPr>
            <a:xfrm rot="16200000">
              <a:off x="1579908" y="1446823"/>
              <a:ext cx="1147118" cy="4844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KSS</a:t>
              </a:r>
            </a:p>
          </p:txBody>
        </p:sp>
      </p:grpSp>
      <p:pic>
        <p:nvPicPr>
          <p:cNvPr id="18" name="Imagen 1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F5B3C04-5E8E-69C1-35D8-3C2B28EF4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1" t="39548" r="38550" b="26628"/>
          <a:stretch/>
        </p:blipFill>
        <p:spPr>
          <a:xfrm>
            <a:off x="397534" y="2574361"/>
            <a:ext cx="3201674" cy="1977506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D1534B06-B5FE-EAB6-5965-B9A4B570DE0D}"/>
              </a:ext>
            </a:extLst>
          </p:cNvPr>
          <p:cNvSpPr txBox="1"/>
          <p:nvPr/>
        </p:nvSpPr>
        <p:spPr>
          <a:xfrm>
            <a:off x="3646357" y="4090202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0A1F41C-2700-357D-9384-3D3BD22E2411}"/>
              </a:ext>
            </a:extLst>
          </p:cNvPr>
          <p:cNvSpPr txBox="1"/>
          <p:nvPr/>
        </p:nvSpPr>
        <p:spPr>
          <a:xfrm>
            <a:off x="3611123" y="265565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22" name="Imagen 21" descr="Un conjunto de letras blancas en un fondo blanco&#10;&#10;Descripción generada automáticamente con confianza baja">
            <a:extLst>
              <a:ext uri="{FF2B5EF4-FFF2-40B4-BE49-F238E27FC236}">
                <a16:creationId xmlns:a16="http://schemas.microsoft.com/office/drawing/2014/main" id="{17F39753-314F-2685-FCBD-A15BCEF87F4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20" t="32685" r="34913" b="25974"/>
          <a:stretch/>
        </p:blipFill>
        <p:spPr>
          <a:xfrm>
            <a:off x="397534" y="4664013"/>
            <a:ext cx="3201674" cy="1985662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744D2C7A-1B73-16C6-8880-9299D0E78B6A}"/>
              </a:ext>
            </a:extLst>
          </p:cNvPr>
          <p:cNvSpPr txBox="1"/>
          <p:nvPr/>
        </p:nvSpPr>
        <p:spPr>
          <a:xfrm>
            <a:off x="3611123" y="5426011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TDSS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4D70574B-5D10-1C14-43F9-77A2A9B57655}"/>
              </a:ext>
            </a:extLst>
          </p:cNvPr>
          <p:cNvSpPr txBox="1"/>
          <p:nvPr/>
        </p:nvSpPr>
        <p:spPr>
          <a:xfrm>
            <a:off x="4782469" y="133654"/>
            <a:ext cx="11801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3H  </a:t>
            </a:r>
          </a:p>
        </p:txBody>
      </p:sp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C9E7231-D7EF-8D1B-17B5-43EFE33BB6C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34" t="36982" r="35046" b="28121"/>
          <a:stretch/>
        </p:blipFill>
        <p:spPr>
          <a:xfrm>
            <a:off x="6273313" y="2574361"/>
            <a:ext cx="3103166" cy="1977507"/>
          </a:xfrm>
          <a:prstGeom prst="rect">
            <a:avLst/>
          </a:prstGeom>
        </p:spPr>
      </p:pic>
      <p:pic>
        <p:nvPicPr>
          <p:cNvPr id="17" name="Imagen 16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5A305BC4-7EFA-33A7-1457-D79C64982F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1" t="28121" r="36017" b="34834"/>
          <a:stretch/>
        </p:blipFill>
        <p:spPr>
          <a:xfrm>
            <a:off x="6174805" y="440528"/>
            <a:ext cx="3201674" cy="2079974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1A47FB04-8917-D8F4-BA99-A8B1893D98F8}"/>
              </a:ext>
            </a:extLst>
          </p:cNvPr>
          <p:cNvSpPr txBox="1"/>
          <p:nvPr/>
        </p:nvSpPr>
        <p:spPr>
          <a:xfrm>
            <a:off x="9579113" y="1140851"/>
            <a:ext cx="936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AEA1F60-DFFE-3C1A-8330-E0C2425A7149}"/>
              </a:ext>
            </a:extLst>
          </p:cNvPr>
          <p:cNvSpPr txBox="1"/>
          <p:nvPr/>
        </p:nvSpPr>
        <p:spPr>
          <a:xfrm>
            <a:off x="9579113" y="3101449"/>
            <a:ext cx="9113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CAT1</a:t>
            </a:r>
          </a:p>
        </p:txBody>
      </p:sp>
    </p:spTree>
    <p:extLst>
      <p:ext uri="{BB962C8B-B14F-4D97-AF65-F5344CB8AC3E}">
        <p14:creationId xmlns:p14="http://schemas.microsoft.com/office/powerpoint/2010/main" val="11796507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A09A749D-BF59-2154-2F18-9C94EDC387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29918" r="46885" b="34217"/>
          <a:stretch/>
        </p:blipFill>
        <p:spPr>
          <a:xfrm>
            <a:off x="397534" y="534841"/>
            <a:ext cx="3201674" cy="1985662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C10A9AE-FA0F-6B93-39FF-8BF1914F4CA9}"/>
              </a:ext>
            </a:extLst>
          </p:cNvPr>
          <p:cNvSpPr txBox="1"/>
          <p:nvPr/>
        </p:nvSpPr>
        <p:spPr>
          <a:xfrm>
            <a:off x="3769206" y="103554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ISD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B97136B3-4AE2-3DE6-E08A-3CDBB2341077}"/>
              </a:ext>
            </a:extLst>
          </p:cNvPr>
          <p:cNvGrpSpPr/>
          <p:nvPr/>
        </p:nvGrpSpPr>
        <p:grpSpPr>
          <a:xfrm>
            <a:off x="2860548" y="422696"/>
            <a:ext cx="594376" cy="862154"/>
            <a:chOff x="3579015" y="1206284"/>
            <a:chExt cx="779607" cy="1184104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1BB3EF02-CDBC-088F-4F78-9FCB7AE9E14C}"/>
                </a:ext>
              </a:extLst>
            </p:cNvPr>
            <p:cNvSpPr txBox="1"/>
            <p:nvPr/>
          </p:nvSpPr>
          <p:spPr>
            <a:xfrm rot="16200000">
              <a:off x="3239561" y="1566503"/>
              <a:ext cx="1163339" cy="4844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CA185479-3ED5-56CE-F1E0-D95C8800715F}"/>
                </a:ext>
              </a:extLst>
            </p:cNvPr>
            <p:cNvSpPr txBox="1"/>
            <p:nvPr/>
          </p:nvSpPr>
          <p:spPr>
            <a:xfrm rot="16200000">
              <a:off x="3542849" y="1537628"/>
              <a:ext cx="1147117" cy="484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ILS</a:t>
              </a:r>
            </a:p>
          </p:txBody>
        </p:sp>
      </p:grpSp>
      <p:pic>
        <p:nvPicPr>
          <p:cNvPr id="18" name="Imagen 1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F5B3C04-5E8E-69C1-35D8-3C2B28EF4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1" t="39548" r="38550" b="26628"/>
          <a:stretch/>
        </p:blipFill>
        <p:spPr>
          <a:xfrm>
            <a:off x="397534" y="2574361"/>
            <a:ext cx="3201674" cy="1977506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D1534B06-B5FE-EAB6-5965-B9A4B570DE0D}"/>
              </a:ext>
            </a:extLst>
          </p:cNvPr>
          <p:cNvSpPr txBox="1"/>
          <p:nvPr/>
        </p:nvSpPr>
        <p:spPr>
          <a:xfrm>
            <a:off x="3646357" y="4090202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0A1F41C-2700-357D-9384-3D3BD22E2411}"/>
              </a:ext>
            </a:extLst>
          </p:cNvPr>
          <p:cNvSpPr txBox="1"/>
          <p:nvPr/>
        </p:nvSpPr>
        <p:spPr>
          <a:xfrm>
            <a:off x="3611123" y="265565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22" name="Imagen 21" descr="Un conjunto de letras blancas en un fondo blanco&#10;&#10;Descripción generada automáticamente con confianza baja">
            <a:extLst>
              <a:ext uri="{FF2B5EF4-FFF2-40B4-BE49-F238E27FC236}">
                <a16:creationId xmlns:a16="http://schemas.microsoft.com/office/drawing/2014/main" id="{17F39753-314F-2685-FCBD-A15BCEF87F4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20" t="32685" r="34913" b="25974"/>
          <a:stretch/>
        </p:blipFill>
        <p:spPr>
          <a:xfrm>
            <a:off x="397534" y="4664013"/>
            <a:ext cx="3201674" cy="1985662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744D2C7A-1B73-16C6-8880-9299D0E78B6A}"/>
              </a:ext>
            </a:extLst>
          </p:cNvPr>
          <p:cNvSpPr txBox="1"/>
          <p:nvPr/>
        </p:nvSpPr>
        <p:spPr>
          <a:xfrm>
            <a:off x="3611123" y="5426011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TDSS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4D70574B-5D10-1C14-43F9-77A2A9B57655}"/>
              </a:ext>
            </a:extLst>
          </p:cNvPr>
          <p:cNvSpPr txBox="1"/>
          <p:nvPr/>
        </p:nvSpPr>
        <p:spPr>
          <a:xfrm>
            <a:off x="4782469" y="133654"/>
            <a:ext cx="11801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4H  </a:t>
            </a:r>
          </a:p>
        </p:txBody>
      </p:sp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C9E7231-D7EF-8D1B-17B5-43EFE33BB6C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34" t="36982" r="35046" b="28121"/>
          <a:stretch/>
        </p:blipFill>
        <p:spPr>
          <a:xfrm>
            <a:off x="6273313" y="2574361"/>
            <a:ext cx="3103166" cy="1977507"/>
          </a:xfrm>
          <a:prstGeom prst="rect">
            <a:avLst/>
          </a:prstGeom>
        </p:spPr>
      </p:pic>
      <p:pic>
        <p:nvPicPr>
          <p:cNvPr id="17" name="Imagen 16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5A305BC4-7EFA-33A7-1457-D79C64982F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1" t="28121" r="36017" b="34834"/>
          <a:stretch/>
        </p:blipFill>
        <p:spPr>
          <a:xfrm>
            <a:off x="6174805" y="440528"/>
            <a:ext cx="3201674" cy="2079974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1A47FB04-8917-D8F4-BA99-A8B1893D98F8}"/>
              </a:ext>
            </a:extLst>
          </p:cNvPr>
          <p:cNvSpPr txBox="1"/>
          <p:nvPr/>
        </p:nvSpPr>
        <p:spPr>
          <a:xfrm>
            <a:off x="9579113" y="1140851"/>
            <a:ext cx="936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AEA1F60-DFFE-3C1A-8330-E0C2425A7149}"/>
              </a:ext>
            </a:extLst>
          </p:cNvPr>
          <p:cNvSpPr txBox="1"/>
          <p:nvPr/>
        </p:nvSpPr>
        <p:spPr>
          <a:xfrm>
            <a:off x="9579113" y="3101449"/>
            <a:ext cx="9113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CAT1</a:t>
            </a:r>
          </a:p>
        </p:txBody>
      </p:sp>
    </p:spTree>
    <p:extLst>
      <p:ext uri="{BB962C8B-B14F-4D97-AF65-F5344CB8AC3E}">
        <p14:creationId xmlns:p14="http://schemas.microsoft.com/office/powerpoint/2010/main" val="3594958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A09A749D-BF59-2154-2F18-9C94EDC387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29918" r="46885" b="34217"/>
          <a:stretch/>
        </p:blipFill>
        <p:spPr>
          <a:xfrm>
            <a:off x="397534" y="534842"/>
            <a:ext cx="3201674" cy="1985661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C10A9AE-FA0F-6B93-39FF-8BF1914F4CA9}"/>
              </a:ext>
            </a:extLst>
          </p:cNvPr>
          <p:cNvSpPr txBox="1"/>
          <p:nvPr/>
        </p:nvSpPr>
        <p:spPr>
          <a:xfrm>
            <a:off x="3769206" y="103554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ISD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B97136B3-4AE2-3DE6-E08A-3CDBB2341077}"/>
              </a:ext>
            </a:extLst>
          </p:cNvPr>
          <p:cNvGrpSpPr/>
          <p:nvPr/>
        </p:nvGrpSpPr>
        <p:grpSpPr>
          <a:xfrm>
            <a:off x="1838672" y="160199"/>
            <a:ext cx="638998" cy="1163357"/>
            <a:chOff x="2238682" y="845763"/>
            <a:chExt cx="838135" cy="1597785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1BB3EF02-CDBC-088F-4F78-9FCB7AE9E14C}"/>
                </a:ext>
              </a:extLst>
            </p:cNvPr>
            <p:cNvSpPr txBox="1"/>
            <p:nvPr/>
          </p:nvSpPr>
          <p:spPr>
            <a:xfrm rot="16200000">
              <a:off x="1690357" y="1394088"/>
              <a:ext cx="1581082" cy="4844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CA185479-3ED5-56CE-F1E0-D95C8800715F}"/>
                </a:ext>
              </a:extLst>
            </p:cNvPr>
            <p:cNvSpPr txBox="1"/>
            <p:nvPr/>
          </p:nvSpPr>
          <p:spPr>
            <a:xfrm rot="16200000">
              <a:off x="2044059" y="1410790"/>
              <a:ext cx="1581086" cy="4844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DUFS4</a:t>
              </a:r>
            </a:p>
          </p:txBody>
        </p:sp>
      </p:grpSp>
      <p:pic>
        <p:nvPicPr>
          <p:cNvPr id="18" name="Imagen 1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F5B3C04-5E8E-69C1-35D8-3C2B28EF4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1" t="39548" r="38550" b="26628"/>
          <a:stretch/>
        </p:blipFill>
        <p:spPr>
          <a:xfrm>
            <a:off x="397534" y="2574361"/>
            <a:ext cx="3201674" cy="1977506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D1534B06-B5FE-EAB6-5965-B9A4B570DE0D}"/>
              </a:ext>
            </a:extLst>
          </p:cNvPr>
          <p:cNvSpPr txBox="1"/>
          <p:nvPr/>
        </p:nvSpPr>
        <p:spPr>
          <a:xfrm>
            <a:off x="3646357" y="4090202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0A1F41C-2700-357D-9384-3D3BD22E2411}"/>
              </a:ext>
            </a:extLst>
          </p:cNvPr>
          <p:cNvSpPr txBox="1"/>
          <p:nvPr/>
        </p:nvSpPr>
        <p:spPr>
          <a:xfrm>
            <a:off x="3611123" y="265565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22" name="Imagen 21" descr="Un conjunto de letras blancas en un fondo blanco&#10;&#10;Descripción generada automáticamente con confianza baja">
            <a:extLst>
              <a:ext uri="{FF2B5EF4-FFF2-40B4-BE49-F238E27FC236}">
                <a16:creationId xmlns:a16="http://schemas.microsoft.com/office/drawing/2014/main" id="{17F39753-314F-2685-FCBD-A15BCEF87F4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20" t="32685" r="34913" b="25974"/>
          <a:stretch/>
        </p:blipFill>
        <p:spPr>
          <a:xfrm>
            <a:off x="397534" y="4664013"/>
            <a:ext cx="3201674" cy="1985662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744D2C7A-1B73-16C6-8880-9299D0E78B6A}"/>
              </a:ext>
            </a:extLst>
          </p:cNvPr>
          <p:cNvSpPr txBox="1"/>
          <p:nvPr/>
        </p:nvSpPr>
        <p:spPr>
          <a:xfrm>
            <a:off x="3611123" y="5426011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TDSS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4D70574B-5D10-1C14-43F9-77A2A9B57655}"/>
              </a:ext>
            </a:extLst>
          </p:cNvPr>
          <p:cNvSpPr txBox="1"/>
          <p:nvPr/>
        </p:nvSpPr>
        <p:spPr>
          <a:xfrm>
            <a:off x="4782469" y="133654"/>
            <a:ext cx="11801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5H  </a:t>
            </a:r>
          </a:p>
        </p:txBody>
      </p:sp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C9E7231-D7EF-8D1B-17B5-43EFE33BB6C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34" t="36982" r="35046" b="28121"/>
          <a:stretch/>
        </p:blipFill>
        <p:spPr>
          <a:xfrm>
            <a:off x="6273313" y="2574361"/>
            <a:ext cx="3103166" cy="1977507"/>
          </a:xfrm>
          <a:prstGeom prst="rect">
            <a:avLst/>
          </a:prstGeom>
        </p:spPr>
      </p:pic>
      <p:pic>
        <p:nvPicPr>
          <p:cNvPr id="17" name="Imagen 16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5A305BC4-7EFA-33A7-1457-D79C64982F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1" t="28121" r="36017" b="34834"/>
          <a:stretch/>
        </p:blipFill>
        <p:spPr>
          <a:xfrm>
            <a:off x="6174805" y="440528"/>
            <a:ext cx="3201674" cy="2079974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1A47FB04-8917-D8F4-BA99-A8B1893D98F8}"/>
              </a:ext>
            </a:extLst>
          </p:cNvPr>
          <p:cNvSpPr txBox="1"/>
          <p:nvPr/>
        </p:nvSpPr>
        <p:spPr>
          <a:xfrm>
            <a:off x="9579113" y="1140851"/>
            <a:ext cx="936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AEA1F60-DFFE-3C1A-8330-E0C2425A7149}"/>
              </a:ext>
            </a:extLst>
          </p:cNvPr>
          <p:cNvSpPr txBox="1"/>
          <p:nvPr/>
        </p:nvSpPr>
        <p:spPr>
          <a:xfrm>
            <a:off x="9579113" y="3101449"/>
            <a:ext cx="9113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CAT1</a:t>
            </a:r>
          </a:p>
        </p:txBody>
      </p:sp>
    </p:spTree>
    <p:extLst>
      <p:ext uri="{BB962C8B-B14F-4D97-AF65-F5344CB8AC3E}">
        <p14:creationId xmlns:p14="http://schemas.microsoft.com/office/powerpoint/2010/main" val="34659747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n 1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F5B3C04-5E8E-69C1-35D8-3C2B28EF4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1" t="39548" r="38550" b="26628"/>
          <a:stretch/>
        </p:blipFill>
        <p:spPr>
          <a:xfrm>
            <a:off x="6205771" y="816290"/>
            <a:ext cx="3201674" cy="1977506"/>
          </a:xfrm>
          <a:prstGeom prst="rect">
            <a:avLst/>
          </a:prstGeom>
        </p:spPr>
      </p:pic>
      <p:sp>
        <p:nvSpPr>
          <p:cNvPr id="20" name="CuadroTexto 19">
            <a:extLst>
              <a:ext uri="{FF2B5EF4-FFF2-40B4-BE49-F238E27FC236}">
                <a16:creationId xmlns:a16="http://schemas.microsoft.com/office/drawing/2014/main" id="{10A1F41C-2700-357D-9384-3D3BD22E2411}"/>
              </a:ext>
            </a:extLst>
          </p:cNvPr>
          <p:cNvSpPr txBox="1"/>
          <p:nvPr/>
        </p:nvSpPr>
        <p:spPr>
          <a:xfrm>
            <a:off x="9696696" y="979216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4D70574B-5D10-1C14-43F9-77A2A9B57655}"/>
              </a:ext>
            </a:extLst>
          </p:cNvPr>
          <p:cNvSpPr txBox="1"/>
          <p:nvPr/>
        </p:nvSpPr>
        <p:spPr>
          <a:xfrm>
            <a:off x="4428471" y="153937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F</a:t>
            </a:r>
          </a:p>
        </p:txBody>
      </p:sp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C9E7231-D7EF-8D1B-17B5-43EFE33BB6C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34" t="36982" r="35046" b="28121"/>
          <a:stretch/>
        </p:blipFill>
        <p:spPr>
          <a:xfrm>
            <a:off x="1122671" y="3124285"/>
            <a:ext cx="3103166" cy="1977507"/>
          </a:xfrm>
          <a:prstGeom prst="rect">
            <a:avLst/>
          </a:prstGeom>
        </p:spPr>
      </p:pic>
      <p:pic>
        <p:nvPicPr>
          <p:cNvPr id="17" name="Imagen 16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5A305BC4-7EFA-33A7-1457-D79C64982F3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1" t="28121" r="36017" b="34834"/>
          <a:stretch/>
        </p:blipFill>
        <p:spPr>
          <a:xfrm>
            <a:off x="1024163" y="816290"/>
            <a:ext cx="3201674" cy="2079974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1A47FB04-8917-D8F4-BA99-A8B1893D98F8}"/>
              </a:ext>
            </a:extLst>
          </p:cNvPr>
          <p:cNvSpPr txBox="1"/>
          <p:nvPr/>
        </p:nvSpPr>
        <p:spPr>
          <a:xfrm>
            <a:off x="4428471" y="1394612"/>
            <a:ext cx="936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AEA1F60-DFFE-3C1A-8330-E0C2425A7149}"/>
              </a:ext>
            </a:extLst>
          </p:cNvPr>
          <p:cNvSpPr txBox="1"/>
          <p:nvPr/>
        </p:nvSpPr>
        <p:spPr>
          <a:xfrm>
            <a:off x="4265834" y="3651373"/>
            <a:ext cx="9113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CAT1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D783C08-592B-5389-9AB0-EFE86781F37A}"/>
              </a:ext>
            </a:extLst>
          </p:cNvPr>
          <p:cNvSpPr txBox="1"/>
          <p:nvPr/>
        </p:nvSpPr>
        <p:spPr>
          <a:xfrm rot="16200000">
            <a:off x="1310898" y="1281283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ρ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8690392A-686A-8CF9-8047-354F6846D7C3}"/>
              </a:ext>
            </a:extLst>
          </p:cNvPr>
          <p:cNvSpPr txBox="1"/>
          <p:nvPr/>
        </p:nvSpPr>
        <p:spPr>
          <a:xfrm rot="16200000">
            <a:off x="1389311" y="1131087"/>
            <a:ext cx="69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24076877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AAB4F967-A81B-55E1-298E-251C6C3DEF26}"/>
              </a:ext>
            </a:extLst>
          </p:cNvPr>
          <p:cNvSpPr txBox="1"/>
          <p:nvPr/>
        </p:nvSpPr>
        <p:spPr>
          <a:xfrm>
            <a:off x="1241733" y="965036"/>
            <a:ext cx="30332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B </a:t>
            </a:r>
          </a:p>
        </p:txBody>
      </p:sp>
      <p:pic>
        <p:nvPicPr>
          <p:cNvPr id="6" name="Imagen 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4C5BD35F-0277-9F17-CE05-48BCCC9731F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91" t="40052" r="39125" b="28051"/>
          <a:stretch/>
        </p:blipFill>
        <p:spPr>
          <a:xfrm>
            <a:off x="1505430" y="1666918"/>
            <a:ext cx="2794675" cy="2751812"/>
          </a:xfrm>
          <a:prstGeom prst="rect">
            <a:avLst/>
          </a:prstGeom>
        </p:spPr>
      </p:pic>
      <p:sp>
        <p:nvSpPr>
          <p:cNvPr id="16" name="CuadroTexto 15">
            <a:extLst>
              <a:ext uri="{FF2B5EF4-FFF2-40B4-BE49-F238E27FC236}">
                <a16:creationId xmlns:a16="http://schemas.microsoft.com/office/drawing/2014/main" id="{12D8EEB2-BE1A-C560-10E2-C93A00C19587}"/>
              </a:ext>
            </a:extLst>
          </p:cNvPr>
          <p:cNvSpPr txBox="1"/>
          <p:nvPr/>
        </p:nvSpPr>
        <p:spPr>
          <a:xfrm>
            <a:off x="4000991" y="3037746"/>
            <a:ext cx="1813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MAMtracker H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E0955724-8C25-A18D-3CDD-5C6D32DED503}"/>
              </a:ext>
            </a:extLst>
          </p:cNvPr>
          <p:cNvSpPr txBox="1"/>
          <p:nvPr/>
        </p:nvSpPr>
        <p:spPr>
          <a:xfrm>
            <a:off x="4000991" y="2001391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20" name="Imagen 19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26D6E26D-83AA-223E-3F08-6D970C3214F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80" t="35814" r="39833" b="36624"/>
          <a:stretch/>
        </p:blipFill>
        <p:spPr>
          <a:xfrm>
            <a:off x="7897454" y="1523579"/>
            <a:ext cx="2956262" cy="2751812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56DAB005-D25D-9055-76BC-B7BBF62B93F9}"/>
              </a:ext>
            </a:extLst>
          </p:cNvPr>
          <p:cNvSpPr txBox="1"/>
          <p:nvPr/>
        </p:nvSpPr>
        <p:spPr>
          <a:xfrm>
            <a:off x="7576569" y="965035"/>
            <a:ext cx="30460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G 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E3D5FF42-3229-7DC1-94B0-E0459FA96DCA}"/>
              </a:ext>
            </a:extLst>
          </p:cNvPr>
          <p:cNvSpPr txBox="1"/>
          <p:nvPr/>
        </p:nvSpPr>
        <p:spPr>
          <a:xfrm>
            <a:off x="10172053" y="2327759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0A9D077-CD70-972A-28B8-0416D879A8FA}"/>
              </a:ext>
            </a:extLst>
          </p:cNvPr>
          <p:cNvSpPr txBox="1"/>
          <p:nvPr/>
        </p:nvSpPr>
        <p:spPr>
          <a:xfrm>
            <a:off x="10282597" y="265547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Mfn2</a:t>
            </a:r>
          </a:p>
        </p:txBody>
      </p:sp>
    </p:spTree>
    <p:extLst>
      <p:ext uri="{BB962C8B-B14F-4D97-AF65-F5344CB8AC3E}">
        <p14:creationId xmlns:p14="http://schemas.microsoft.com/office/powerpoint/2010/main" val="15179942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70</Words>
  <Application>Microsoft Office PowerPoint</Application>
  <PresentationFormat>Panorámica</PresentationFormat>
  <Paragraphs>48</Paragraphs>
  <Slides>6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orcillo, Patricia</dc:creator>
  <cp:lastModifiedBy>Morcillo, Patricia</cp:lastModifiedBy>
  <cp:revision>8</cp:revision>
  <dcterms:created xsi:type="dcterms:W3CDTF">2024-04-19T16:22:28Z</dcterms:created>
  <dcterms:modified xsi:type="dcterms:W3CDTF">2024-04-19T19:01:26Z</dcterms:modified>
</cp:coreProperties>
</file>